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2304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18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571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544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56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922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243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84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178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26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019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33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29D9D-B1DF-4985-A8B5-5D085CAE2AB0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8F2F8-C5B8-4D79-80AD-41A3EAD61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444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D6D85C9-1B12-4DE1-94BB-ED028E382F23}"/>
              </a:ext>
            </a:extLst>
          </p:cNvPr>
          <p:cNvGrpSpPr/>
          <p:nvPr/>
        </p:nvGrpSpPr>
        <p:grpSpPr>
          <a:xfrm>
            <a:off x="1321873" y="827427"/>
            <a:ext cx="2063372" cy="1904302"/>
            <a:chOff x="1321873" y="1000472"/>
            <a:chExt cx="2063372" cy="190430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466" b="10347"/>
            <a:stretch/>
          </p:blipFill>
          <p:spPr>
            <a:xfrm>
              <a:off x="1321873" y="1000472"/>
              <a:ext cx="2020478" cy="190430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DBCF4DD-51B1-4D45-957E-2378307B2BF2}"/>
                </a:ext>
              </a:extLst>
            </p:cNvPr>
            <p:cNvSpPr txBox="1"/>
            <p:nvPr/>
          </p:nvSpPr>
          <p:spPr>
            <a:xfrm>
              <a:off x="1358731" y="2608910"/>
              <a:ext cx="5631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B050"/>
                  </a:solidFill>
                </a:rPr>
                <a:t>AATAG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2806242" y="2454636"/>
              <a:ext cx="215779" cy="87002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2909058" y="2298275"/>
              <a:ext cx="178634" cy="156361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3011531" y="2461496"/>
              <a:ext cx="373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X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402808" y="1185771"/>
              <a:ext cx="2227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4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 flipV="1">
              <a:off x="2174619" y="1403025"/>
              <a:ext cx="241152" cy="9766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V="1">
              <a:off x="2347507" y="1403025"/>
              <a:ext cx="148973" cy="23213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1360761" y="1030826"/>
              <a:ext cx="313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A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4AE7D375-2FE0-4A35-ADF8-ACA84A58B4C8}"/>
              </a:ext>
            </a:extLst>
          </p:cNvPr>
          <p:cNvGrpSpPr/>
          <p:nvPr/>
        </p:nvGrpSpPr>
        <p:grpSpPr>
          <a:xfrm>
            <a:off x="3505622" y="833990"/>
            <a:ext cx="2008163" cy="1901952"/>
            <a:chOff x="3505622" y="997275"/>
            <a:chExt cx="2008163" cy="1901952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8201" y="997275"/>
              <a:ext cx="2005584" cy="1901952"/>
            </a:xfrm>
            <a:prstGeom prst="rect">
              <a:avLst/>
            </a:prstGeom>
          </p:spPr>
        </p:pic>
        <p:cxnSp>
          <p:nvCxnSpPr>
            <p:cNvPr id="16" name="Straight Connector 15"/>
            <p:cNvCxnSpPr/>
            <p:nvPr/>
          </p:nvCxnSpPr>
          <p:spPr>
            <a:xfrm>
              <a:off x="4497933" y="2414430"/>
              <a:ext cx="215779" cy="87002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677112" y="2013327"/>
              <a:ext cx="102272" cy="401103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4703223" y="2421291"/>
              <a:ext cx="373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X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616900" y="1107721"/>
              <a:ext cx="2227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4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 flipH="1" flipV="1">
              <a:off x="4727308" y="1318277"/>
              <a:ext cx="1" cy="20810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 flipV="1">
              <a:off x="4803468" y="1318277"/>
              <a:ext cx="235478" cy="117761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DBCF4DD-51B1-4D45-957E-2378307B2BF2}"/>
                </a:ext>
              </a:extLst>
            </p:cNvPr>
            <p:cNvSpPr txBox="1"/>
            <p:nvPr/>
          </p:nvSpPr>
          <p:spPr>
            <a:xfrm>
              <a:off x="3505622" y="2608911"/>
              <a:ext cx="13404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B050"/>
                  </a:solidFill>
                </a:rPr>
                <a:t>AATAG  </a:t>
              </a:r>
              <a:r>
                <a:rPr lang="en-US" sz="1000" dirty="0">
                  <a:solidFill>
                    <a:srgbClr val="FF0000"/>
                  </a:solidFill>
                </a:rPr>
                <a:t>anti-</a:t>
              </a:r>
              <a:r>
                <a:rPr lang="en-US" sz="1000" dirty="0" err="1">
                  <a:solidFill>
                    <a:srgbClr val="FF0000"/>
                  </a:solidFill>
                </a:rPr>
                <a:t>CidM</a:t>
              </a:r>
              <a:endParaRPr lang="en-US" sz="1000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06269" y="1020789"/>
              <a:ext cx="313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B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F6356B9-B270-453A-B6F3-60200187A4C5}"/>
              </a:ext>
            </a:extLst>
          </p:cNvPr>
          <p:cNvGrpSpPr/>
          <p:nvPr/>
        </p:nvGrpSpPr>
        <p:grpSpPr>
          <a:xfrm>
            <a:off x="3653174" y="2865450"/>
            <a:ext cx="2204825" cy="1914525"/>
            <a:chOff x="3653174" y="6579450"/>
            <a:chExt cx="2204825" cy="1914525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8E2115C3-3057-4B4A-B80D-F1AFC29174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385"/>
            <a:stretch/>
          </p:blipFill>
          <p:spPr>
            <a:xfrm>
              <a:off x="3653174" y="6579450"/>
              <a:ext cx="1855689" cy="1914525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A757140-2511-4114-97D3-084741E1BEAB}"/>
                </a:ext>
              </a:extLst>
            </p:cNvPr>
            <p:cNvSpPr txBox="1"/>
            <p:nvPr/>
          </p:nvSpPr>
          <p:spPr>
            <a:xfrm>
              <a:off x="4534988" y="6611752"/>
              <a:ext cx="958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AATAGAAGAG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39E28B9-F9C7-4936-8785-7C9838C19714}"/>
                </a:ext>
              </a:extLst>
            </p:cNvPr>
            <p:cNvSpPr txBox="1"/>
            <p:nvPr/>
          </p:nvSpPr>
          <p:spPr>
            <a:xfrm>
              <a:off x="5283406" y="6875516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Y</a:t>
              </a: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611049A6-6FCB-4392-86AE-BC5C3B4BB7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69589" y="7072725"/>
              <a:ext cx="156485" cy="134456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307AED1-9A96-45CF-92DA-520BEE7E90EC}"/>
                </a:ext>
              </a:extLst>
            </p:cNvPr>
            <p:cNvSpPr txBox="1"/>
            <p:nvPr/>
          </p:nvSpPr>
          <p:spPr>
            <a:xfrm>
              <a:off x="4028394" y="7207181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X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5AEDA66-3569-4C5E-8EA4-B8812630A386}"/>
                </a:ext>
              </a:extLst>
            </p:cNvPr>
            <p:cNvSpPr txBox="1"/>
            <p:nvPr/>
          </p:nvSpPr>
          <p:spPr>
            <a:xfrm>
              <a:off x="3668829" y="6590768"/>
              <a:ext cx="313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EDBE399-1D86-41B5-9CA5-4455EE177665}"/>
                </a:ext>
              </a:extLst>
            </p:cNvPr>
            <p:cNvSpPr txBox="1"/>
            <p:nvPr/>
          </p:nvSpPr>
          <p:spPr>
            <a:xfrm>
              <a:off x="4330159" y="7220337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4s</a:t>
              </a: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1315182" y="2864724"/>
            <a:ext cx="2243927" cy="1915251"/>
            <a:chOff x="1315182" y="6415439"/>
            <a:chExt cx="2243927" cy="1915251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212206CF-13DA-4DD0-BC2C-30E96EBC03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62" t="8519" r="20586" b="9397"/>
            <a:stretch/>
          </p:blipFill>
          <p:spPr>
            <a:xfrm rot="16200000">
              <a:off x="1479652" y="6251232"/>
              <a:ext cx="1914988" cy="2243927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192B2FF-DB9B-4BCB-AA81-B3F76A97D143}"/>
                </a:ext>
              </a:extLst>
            </p:cNvPr>
            <p:cNvSpPr txBox="1"/>
            <p:nvPr/>
          </p:nvSpPr>
          <p:spPr>
            <a:xfrm>
              <a:off x="2542836" y="6439067"/>
              <a:ext cx="10079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AATAGAATTG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F68C9B2-D288-406F-B5E3-4DA5164090CA}"/>
                </a:ext>
              </a:extLst>
            </p:cNvPr>
            <p:cNvSpPr txBox="1"/>
            <p:nvPr/>
          </p:nvSpPr>
          <p:spPr>
            <a:xfrm>
              <a:off x="1804825" y="7458857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X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D482D68-420E-43D3-B60F-8F293A2E0F46}"/>
                </a:ext>
              </a:extLst>
            </p:cNvPr>
            <p:cNvSpPr txBox="1"/>
            <p:nvPr/>
          </p:nvSpPr>
          <p:spPr>
            <a:xfrm>
              <a:off x="1581677" y="6920786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Y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D0BDC3C-2ADD-4359-841A-9AC7FDDE7110}"/>
                </a:ext>
              </a:extLst>
            </p:cNvPr>
            <p:cNvSpPr txBox="1"/>
            <p:nvPr/>
          </p:nvSpPr>
          <p:spPr>
            <a:xfrm>
              <a:off x="2496480" y="8009878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0EC1964-3842-4E78-85DD-51062A2CF4A1}"/>
                </a:ext>
              </a:extLst>
            </p:cNvPr>
            <p:cNvSpPr txBox="1"/>
            <p:nvPr/>
          </p:nvSpPr>
          <p:spPr>
            <a:xfrm>
              <a:off x="1587559" y="7918314"/>
              <a:ext cx="5745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>
                  <a:solidFill>
                    <a:schemeClr val="bg1"/>
                  </a:solidFill>
                </a:rPr>
                <a:t>4</a:t>
              </a: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BD315993-7EB8-47A0-A111-D461910AD5BB}"/>
                </a:ext>
              </a:extLst>
            </p:cNvPr>
            <p:cNvCxnSpPr>
              <a:cxnSpLocks/>
            </p:cNvCxnSpPr>
            <p:nvPr/>
          </p:nvCxnSpPr>
          <p:spPr>
            <a:xfrm>
              <a:off x="1804825" y="7105963"/>
              <a:ext cx="387737" cy="742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E5AFB19-EC27-4297-8682-7590B18303B5}"/>
                </a:ext>
              </a:extLst>
            </p:cNvPr>
            <p:cNvSpPr txBox="1"/>
            <p:nvPr/>
          </p:nvSpPr>
          <p:spPr>
            <a:xfrm>
              <a:off x="1322655" y="6415439"/>
              <a:ext cx="313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</a:rPr>
                <a:t>C</a:t>
              </a:r>
              <a:endParaRPr lang="en-US" sz="1000" dirty="0">
                <a:solidFill>
                  <a:schemeClr val="bg1"/>
                </a:solidFill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21873" y="4937620"/>
            <a:ext cx="4171211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2. </a:t>
            </a:r>
            <a:r>
              <a:rPr lang="en-US" sz="1200" dirty="0" smtClean="0"/>
              <a:t>(A</a:t>
            </a:r>
            <a:r>
              <a:rPr lang="en-US" sz="1200" dirty="0"/>
              <a:t>) Hybridization of the (AATAG)</a:t>
            </a:r>
            <a:r>
              <a:rPr lang="en-US" sz="1200" baseline="-25000" dirty="0"/>
              <a:t>10 </a:t>
            </a:r>
            <a:r>
              <a:rPr lang="en-US" sz="1200" dirty="0"/>
              <a:t>probe to chromosomes </a:t>
            </a:r>
            <a:r>
              <a:rPr lang="en-US" sz="1200" i="1" dirty="0"/>
              <a:t>X</a:t>
            </a:r>
            <a:r>
              <a:rPr lang="en-US" sz="1200" dirty="0"/>
              <a:t> and </a:t>
            </a:r>
            <a:r>
              <a:rPr lang="en-US" sz="1200" i="1" dirty="0"/>
              <a:t>4</a:t>
            </a:r>
            <a:r>
              <a:rPr lang="en-US" sz="1200" dirty="0"/>
              <a:t> of </a:t>
            </a:r>
            <a:r>
              <a:rPr lang="en-US" sz="1200" i="1" dirty="0"/>
              <a:t>D. </a:t>
            </a:r>
            <a:r>
              <a:rPr lang="en-US" sz="1200" i="1" dirty="0" err="1"/>
              <a:t>simulans</a:t>
            </a:r>
            <a:r>
              <a:rPr lang="en-US" sz="1200" dirty="0"/>
              <a:t> larval brain squashes. (B) (AATAG)</a:t>
            </a:r>
            <a:r>
              <a:rPr lang="en-US" sz="1200" baseline="-25000" dirty="0"/>
              <a:t>10</a:t>
            </a:r>
            <a:r>
              <a:rPr lang="en-US" sz="1200" dirty="0"/>
              <a:t> hybridization together with CENP-A detection using the anti-</a:t>
            </a:r>
            <a:r>
              <a:rPr lang="en-US" sz="1200" dirty="0" err="1"/>
              <a:t>CidM</a:t>
            </a:r>
            <a:r>
              <a:rPr lang="en-US" sz="1200" dirty="0"/>
              <a:t> </a:t>
            </a:r>
            <a:r>
              <a:rPr lang="en-US" sz="1200" dirty="0" smtClean="0"/>
              <a:t>antibody and formaldehyde fixation</a:t>
            </a:r>
            <a:r>
              <a:rPr lang="en-US" sz="1200" smtClean="0"/>
              <a:t>. </a:t>
            </a:r>
          </a:p>
          <a:p>
            <a:r>
              <a:rPr lang="en-US" sz="1200" smtClean="0"/>
              <a:t>(</a:t>
            </a:r>
            <a:r>
              <a:rPr lang="en-US" sz="1200" dirty="0" smtClean="0"/>
              <a:t>C) </a:t>
            </a:r>
            <a:r>
              <a:rPr lang="en-US" sz="1200" dirty="0"/>
              <a:t>Hybridization of (AATAGAATTG)</a:t>
            </a:r>
            <a:r>
              <a:rPr lang="en-US" sz="1200" baseline="-25000" dirty="0"/>
              <a:t>3</a:t>
            </a:r>
            <a:r>
              <a:rPr lang="en-US" sz="1200" dirty="0"/>
              <a:t> probe to chromosomes </a:t>
            </a:r>
            <a:r>
              <a:rPr lang="en-US" sz="1200" i="1" dirty="0"/>
              <a:t>4</a:t>
            </a:r>
            <a:r>
              <a:rPr lang="en-US" sz="1200" dirty="0"/>
              <a:t> and </a:t>
            </a:r>
            <a:r>
              <a:rPr lang="en-US" sz="1200" i="1" dirty="0"/>
              <a:t>X</a:t>
            </a:r>
            <a:r>
              <a:rPr lang="en-US" sz="1200" dirty="0"/>
              <a:t>. </a:t>
            </a:r>
            <a:r>
              <a:rPr lang="en-US" sz="1200" dirty="0" smtClean="0"/>
              <a:t>(D) </a:t>
            </a:r>
            <a:r>
              <a:rPr lang="en-US" sz="1200" dirty="0"/>
              <a:t>Hybridization of (AATAGAAGAG)</a:t>
            </a:r>
            <a:r>
              <a:rPr lang="en-US" sz="1200" baseline="-25000" dirty="0"/>
              <a:t>3</a:t>
            </a:r>
            <a:r>
              <a:rPr lang="en-US" sz="1200" dirty="0"/>
              <a:t> probe to chromosomes </a:t>
            </a:r>
            <a:r>
              <a:rPr lang="en-US" sz="1200" i="1" dirty="0"/>
              <a:t>X</a:t>
            </a:r>
            <a:r>
              <a:rPr lang="en-US" sz="1200" dirty="0"/>
              <a:t> and </a:t>
            </a:r>
            <a:r>
              <a:rPr lang="en-US" sz="1200" i="1" dirty="0"/>
              <a:t>Y</a:t>
            </a:r>
            <a:r>
              <a:rPr lang="en-US" sz="1200" dirty="0"/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9305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</TotalTime>
  <Words>91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red Hut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lbert, Paul</dc:creator>
  <cp:lastModifiedBy>Talbert, Paul</cp:lastModifiedBy>
  <cp:revision>4</cp:revision>
  <dcterms:created xsi:type="dcterms:W3CDTF">2017-12-08T20:45:59Z</dcterms:created>
  <dcterms:modified xsi:type="dcterms:W3CDTF">2017-12-09T03:04:49Z</dcterms:modified>
</cp:coreProperties>
</file>